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>
      <p:cViewPr>
        <p:scale>
          <a:sx n="88" d="100"/>
          <a:sy n="88" d="100"/>
        </p:scale>
        <p:origin x="48" y="-48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tharine Bee" userId="518cbc4e-21f5-49b9-8ff7-9bc2e9391ef0" providerId="ADAL" clId="{327B3957-B792-49C3-8360-2CBF44389969}"/>
    <pc:docChg chg="modSld">
      <pc:chgData name="Katharine Bee" userId="518cbc4e-21f5-49b9-8ff7-9bc2e9391ef0" providerId="ADAL" clId="{327B3957-B792-49C3-8360-2CBF44389969}" dt="2022-07-07T00:51:42.972" v="1" actId="20577"/>
      <pc:docMkLst>
        <pc:docMk/>
      </pc:docMkLst>
      <pc:sldChg chg="modSp mod">
        <pc:chgData name="Katharine Bee" userId="518cbc4e-21f5-49b9-8ff7-9bc2e9391ef0" providerId="ADAL" clId="{327B3957-B792-49C3-8360-2CBF44389969}" dt="2022-07-07T00:51:42.972" v="1" actId="20577"/>
        <pc:sldMkLst>
          <pc:docMk/>
          <pc:sldMk cId="1160946794" sldId="262"/>
        </pc:sldMkLst>
        <pc:graphicFrameChg chg="modGraphic">
          <ac:chgData name="Katharine Bee" userId="518cbc4e-21f5-49b9-8ff7-9bc2e9391ef0" providerId="ADAL" clId="{327B3957-B792-49C3-8360-2CBF44389969}" dt="2022-07-07T00:51:42.972" v="1" actId="20577"/>
          <ac:graphicFrameMkLst>
            <pc:docMk/>
            <pc:sldMk cId="1160946794" sldId="262"/>
            <ac:graphicFrameMk id="3" creationId="{67262299-3095-F160-973B-1CBB6D85FB6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B2EB3-A124-0853-CA1E-F6C4F0C88C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F792AF-2B22-E661-6515-37E831D0E1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29A85-9FFB-96EE-4E56-41A1FD4AB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2BDFA2-7080-4DDE-21C5-942499A57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7F6506-172C-9E5C-7C40-0B9447677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396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9A69FE-1C23-9859-80F4-50394E05C5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8E6A84-2464-A90C-BDB0-32036EFEA8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4E42B7-8EAD-7649-74E7-8B9BC787F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D967BC-273F-70F6-27AA-293E7987F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5833AC-BD8E-9196-FBE9-2D530D499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474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B6F8EA-3703-E6F7-C2FC-8428C70BB2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765B3E-7003-7BD1-BD88-B88A96F0C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582B6F-A402-2D57-2800-2FA4B2B8A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6E2AA9-B58E-444A-33E8-155D4B999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8C37B-903E-ACC5-890C-65CA541D9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70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F88498-D460-0625-4082-F5ADFE390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3B5C12-6234-79ED-6465-6C42B1B69C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340B5-0DD4-B60A-2643-3BFE33DD1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47C99-0CFA-D50B-9965-AAB6BFE19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844EED-AD02-FAAD-C5B5-06F6BDF47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714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13D2E2-749D-E64C-9E19-F9E410B37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F140AD-852D-3875-5346-444B658478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430F79-45A4-72A4-16C7-5616D297F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C6C168-FE77-D6D1-1F1F-5D7CDC441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A9FC17-2237-97E7-36C6-5605C6EA2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481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D4A86-8A38-5DB1-78FC-074E05AF3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ADBCD3-2F71-B1CD-AE37-8AA50ECA52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59A2B0-E754-651E-74DF-8C4663FE61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3BDDD1-08C9-3F83-7867-EBD253A73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4DB268-6BE9-1B8C-E5C3-4CCD0A1F53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621A1-0633-C519-5558-C76AEE4EF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821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984C9-7C75-6EE2-40FF-1F93262C42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5E8F87-A823-9E81-2602-A2433FD4D4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0A87D3-8149-EF47-50B5-4F4E973EE3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9C80BD-B76F-D9C4-67C2-326127AF1B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9D9B3E-C769-FB58-CB16-1B10458E9A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4C41BA-DD5C-7BFF-698D-570EBE549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BE97710-82DE-64D1-7194-80B40171F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2D02469-7807-45D2-08E8-8F2EA5F9F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872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FDDDE-11D2-A07C-BC42-DE52F8364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7153BB-EB4B-124D-99F3-5B6C61D98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C6353E-73BA-2E4D-DAF9-1CAAAF0C3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C14AE4-8799-CDCC-12BF-21508CC7E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685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65AA9A-8B1D-6E95-2283-3756501D7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B4B660-340C-5307-4200-37474BD7D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DA45ED-F8F9-897D-D6D4-B2AFE2C39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55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320A28-D241-D18A-2033-E1D8A88C1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9A7615-FE1A-7168-8CEE-61EE874B7C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083D67-A0BE-56E9-26A6-B58E7C9B63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CBA213-E64C-124F-DF69-F0833BF7B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98D060-EAD9-4166-472D-48C90EE3C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6DB76B-F1F5-8538-73AB-377B29EE0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800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92C62-E6ED-4E8D-5DE4-3B426E31A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557E67-213C-5D66-50F0-8ED2F13BF7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8A5887-B0B4-8B66-2957-9230E004E7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01B637-0FA5-0E6C-516B-2E775469F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8A8196-2116-4D84-0E66-DD2E540B7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BC4607-83BE-BB61-6C01-9D126CB14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113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985CB6-90D7-9071-69BA-C6DA1AC8A7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376A55-F1AD-63D1-0E61-91C4A99038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567F19-464D-7786-B7CB-CF3804702E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2FFF67-AE41-4FE8-BC1B-57BE180BABD8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F3706B-3D5C-A220-1527-260E13CFE4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BBBE53-7177-3DD5-60FA-94DD6485FA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A3CF4-A936-4E31-B5DD-2D95782A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280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6B1BCE8-6F5F-7F44-2944-3A923ED3A711}"/>
              </a:ext>
            </a:extLst>
          </p:cNvPr>
          <p:cNvSpPr txBox="1"/>
          <p:nvPr/>
        </p:nvSpPr>
        <p:spPr>
          <a:xfrm>
            <a:off x="0" y="0"/>
            <a:ext cx="2502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E4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7262299-3095-F160-973B-1CBB6D85FB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5378568"/>
              </p:ext>
            </p:extLst>
          </p:nvPr>
        </p:nvGraphicFramePr>
        <p:xfrm>
          <a:off x="1922096" y="1370001"/>
          <a:ext cx="6972300" cy="1667510"/>
        </p:xfrm>
        <a:graphic>
          <a:graphicData uri="http://schemas.openxmlformats.org/drawingml/2006/table">
            <a:tbl>
              <a:tblPr firstRow="1" firstCol="1" bandRow="1"/>
              <a:tblGrid>
                <a:gridCol w="1800121">
                  <a:extLst>
                    <a:ext uri="{9D8B030D-6E8A-4147-A177-3AD203B41FA5}">
                      <a16:colId xmlns:a16="http://schemas.microsoft.com/office/drawing/2014/main" val="2058495145"/>
                    </a:ext>
                  </a:extLst>
                </a:gridCol>
                <a:gridCol w="1318399">
                  <a:extLst>
                    <a:ext uri="{9D8B030D-6E8A-4147-A177-3AD203B41FA5}">
                      <a16:colId xmlns:a16="http://schemas.microsoft.com/office/drawing/2014/main" val="3318673861"/>
                    </a:ext>
                  </a:extLst>
                </a:gridCol>
                <a:gridCol w="1242337">
                  <a:extLst>
                    <a:ext uri="{9D8B030D-6E8A-4147-A177-3AD203B41FA5}">
                      <a16:colId xmlns:a16="http://schemas.microsoft.com/office/drawing/2014/main" val="3752508628"/>
                    </a:ext>
                  </a:extLst>
                </a:gridCol>
                <a:gridCol w="1533906">
                  <a:extLst>
                    <a:ext uri="{9D8B030D-6E8A-4147-A177-3AD203B41FA5}">
                      <a16:colId xmlns:a16="http://schemas.microsoft.com/office/drawing/2014/main" val="2121752623"/>
                    </a:ext>
                  </a:extLst>
                </a:gridCol>
                <a:gridCol w="1077537">
                  <a:extLst>
                    <a:ext uri="{9D8B030D-6E8A-4147-A177-3AD203B41FA5}">
                      <a16:colId xmlns:a16="http://schemas.microsoft.com/office/drawing/2014/main" val="715935420"/>
                    </a:ext>
                  </a:extLst>
                </a:gridCol>
              </a:tblGrid>
              <a:tr h="63754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ubgroup </a:t>
                      </a:r>
                      <a:b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</a:b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(ongoing history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Viaskin Peanut </a:t>
                      </a:r>
                      <a:b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</a:b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250 µg response rate</a:t>
                      </a:r>
                      <a:b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</a:b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% (n/N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Placebo response rate</a:t>
                      </a:r>
                      <a:b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</a:b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% (n/N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Difference </a:t>
                      </a:r>
                      <a:b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</a:b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P</a:t>
                      </a: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 value for interac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4246514"/>
                  </a:ext>
                </a:extLst>
              </a:tr>
              <a:tr h="9055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With the 3 diagnoses: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Yes (N=6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No (N=292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37.2 (16/43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34.9 (68/19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9.5 (2/21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4.4 (14/97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27.7% (4.4–44.1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20.4% (10.0–29.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0.51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1397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60946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0910E230E33434A8F72B935337CA89F" ma:contentTypeVersion="12" ma:contentTypeDescription="Create a new document." ma:contentTypeScope="" ma:versionID="b3ff08a6f125daa8ebdd740d7b02ce8d">
  <xsd:schema xmlns:xsd="http://www.w3.org/2001/XMLSchema" xmlns:xs="http://www.w3.org/2001/XMLSchema" xmlns:p="http://schemas.microsoft.com/office/2006/metadata/properties" xmlns:ns2="95734648-81ed-4cb3-86b2-a255be970428" xmlns:ns3="e2ccda8d-dc0e-4ba9-a702-5fb58a589676" targetNamespace="http://schemas.microsoft.com/office/2006/metadata/properties" ma:root="true" ma:fieldsID="a265fdcba77d5f8ff2fc6162e3c01732" ns2:_="" ns3:_="">
    <xsd:import namespace="95734648-81ed-4cb3-86b2-a255be970428"/>
    <xsd:import namespace="e2ccda8d-dc0e-4ba9-a702-5fb58a58967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EventHashCode" minOccurs="0"/>
                <xsd:element ref="ns2:MediaServiceGenerationTime" minOccurs="0"/>
                <xsd:element ref="ns2:MediaServiceAutoTags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734648-81ed-4cb3-86b2-a255be9704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Tags" ma:index="14" nillable="true" ma:displayName="MediaServiceAutoTags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ccda8d-dc0e-4ba9-a702-5fb58a589676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BD48B2A-DC01-48C8-A094-3772D3BC4217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974E2348-4ED0-4315-AEB5-D7FB3825229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8514B43-7608-45AF-A1C1-308D977DACB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5734648-81ed-4cb3-86b2-a255be970428"/>
    <ds:schemaRef ds:uri="e2ccda8d-dc0e-4ba9-a702-5fb58a58967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ne Campbell</dc:creator>
  <cp:lastModifiedBy>Katharine Bee</cp:lastModifiedBy>
  <cp:revision>1</cp:revision>
  <dcterms:created xsi:type="dcterms:W3CDTF">2022-06-23T04:49:24Z</dcterms:created>
  <dcterms:modified xsi:type="dcterms:W3CDTF">2022-07-07T00:51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0910E230E33434A8F72B935337CA89F</vt:lpwstr>
  </property>
</Properties>
</file>